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11"/>
  </p:handoutMasterIdLst>
  <p:sldIdLst>
    <p:sldId id="289" r:id="rId2"/>
    <p:sldId id="299" r:id="rId3"/>
    <p:sldId id="265" r:id="rId4"/>
    <p:sldId id="303" r:id="rId5"/>
    <p:sldId id="305" r:id="rId6"/>
    <p:sldId id="313" r:id="rId7"/>
    <p:sldId id="317" r:id="rId8"/>
    <p:sldId id="316" r:id="rId9"/>
    <p:sldId id="320" r:id="rId10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38" autoAdjust="0"/>
    <p:restoredTop sz="94660"/>
  </p:normalViewPr>
  <p:slideViewPr>
    <p:cSldViewPr snapToGrid="0">
      <p:cViewPr varScale="1">
        <p:scale>
          <a:sx n="89" d="100"/>
          <a:sy n="89" d="100"/>
        </p:scale>
        <p:origin x="-180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8.v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image" Target="../media/image14.emf"/></Relationships>
</file>

<file path=ppt/drawings/_rels/vmlDrawing9.v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image" Target="../media/image16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216246-E8C5-4D93-9E24-4AF25448B785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17231-4C00-43E3-884E-CFB82A5A1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7253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D018A09-1756-43E7-9781-A0A105D456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3C8AC7C2-9946-48B9-BAB4-133E4C1CB1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298ED4C-4B8A-4D8D-9E82-2B6F95D4E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FB9FAD5-5381-47A8-89C2-F90276F10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83D1B27-C47C-415E-8B75-84ACEA7C7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519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30C5091-C638-4E7A-936B-9D5434A674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580B059B-A588-4522-BB0A-F88D91BDEB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DAD7DBB-304C-4177-896A-B2D5EC27D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21A08E5-807B-49C0-89F4-4A80B24C2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2C9B6403-4A1F-4775-B89A-18116D0AE1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1111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A8F12AD0-E2EF-4E37-80EA-9A874F7410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634EBAC1-714D-471E-8C71-8CC3D20F2B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25D8886-D45D-438A-9835-3D6EC1725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64D3E24-6043-4B15-BFDE-CF47E3AF8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DE227EF2-A205-4E1C-AF8F-D31AB34F3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2893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0D72FC2-4680-494F-960A-4F7E33D4D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7DBD12E3-284F-4053-825D-FFFE95F10D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E042E0E3-FFF6-405E-AFB2-0B3E1699C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15B038D4-DB3C-479A-BD5F-A41B109D5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0FA57DC-D039-45CC-B224-4A68048FA1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7853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1D119DB-61A4-44FA-AC1C-AECC5C1F34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FA22301F-90EA-4899-BF45-A6D4C0BB10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1E37B2E-A0F0-4938-B632-79FB44178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BF781C84-272B-41A5-AC1C-E753B6252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A9A49A1-9393-49AE-8347-21DCD9B9F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543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29F545D-5F4A-4ACB-B5B7-7F5877D328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5CDF591B-FDFB-4F17-8180-5ADF92BEE9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D1EFA55A-E74B-4C6F-9705-112C62956C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F7638F9F-1DC4-4952-B702-7D9D31D67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C83772F8-E143-4FC2-85C6-B9BC609DE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DC93141-643E-4ADB-87CF-46DA94723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5121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85E5F9E-73DB-4F71-816D-750B015E3E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5BB1B58F-EA4F-4FC9-95AB-016E6406BF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41A89221-DAB4-4B49-A9A5-5FE48284C8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6028FAD3-A20F-4DDC-B361-4CF11CFC9E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E66813A3-2B25-4BB6-93F8-9EA9C82D8A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64FF8A4A-220C-4F59-99E7-9D8E56DFA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541811F8-F4E4-43DB-88ED-AA38ABCE9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4DCD056E-66DF-4618-B848-64E8F0EBEF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2549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ACC2830-53E8-4F56-9D16-2114E851D6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9DE19248-2695-45BA-8704-BF95D5577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B467BF3A-8927-44D4-A791-32CC4A5BB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8D3F895C-A5D6-4595-94FD-44B5285F9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1585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F442F0FD-6B9B-46BD-A4D1-0A9D03B33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F0AC92B6-CA74-4614-8755-873BA82FC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885C484B-0B6D-4520-8F30-F464E0310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0362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AB45385-D77E-45FC-9E47-1A260353EC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52601E74-F3F7-4ACE-A979-D74DBA14FD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BAD82419-DB60-444E-AC37-CA8AA1B1EB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A070A5A2-9A6F-4143-8638-3203AA0B1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2EEE25B0-7C83-493F-A1BB-C0388A29B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1F3A265E-8FB0-4728-AFEB-729E84C7E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053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B703D63-BA1B-41BB-93E2-7466B9DDE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E8E58C91-8740-4510-B60A-1A4FEBD8C6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46F77689-61A6-4E16-A491-C3E0AFEE64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7F84842A-B7C0-4EA7-9A25-1184AE8F2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EAC4DCF9-163E-459A-84E3-D47252ADC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D6A3B986-B5B2-478D-B8CE-D1BC955DA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6174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ECA58078-6280-46B3-9997-F66C789176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BD041FB1-156A-4877-8CA9-BA7BE48240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5004557-9672-44CD-965C-98A4390496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1520C-7ADD-4662-87ED-F4CF4B039A74}" type="datetimeFigureOut">
              <a:rPr kumimoji="1" lang="ja-JP" altLang="en-US" smtClean="0"/>
              <a:t>2022/10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905DCC48-6C96-470F-8B9A-1209E31175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AA5B49B-C54A-4989-910F-9260975113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74DD8D-3A32-434B-912D-DC6512E60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7561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12.emf"/><Relationship Id="rId5" Type="http://schemas.openxmlformats.org/officeDocument/2006/relationships/oleObject" Target="../embeddings/oleObject12.bin"/><Relationship Id="rId4" Type="http://schemas.openxmlformats.org/officeDocument/2006/relationships/image" Target="../media/image1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13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15.emf"/><Relationship Id="rId5" Type="http://schemas.openxmlformats.org/officeDocument/2006/relationships/oleObject" Target="../embeddings/oleObject15.bin"/><Relationship Id="rId4" Type="http://schemas.openxmlformats.org/officeDocument/2006/relationships/image" Target="../media/image14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17.emf"/><Relationship Id="rId5" Type="http://schemas.openxmlformats.org/officeDocument/2006/relationships/oleObject" Target="../embeddings/oleObject17.bin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xmlns="" id="{A0DB4594-0594-48DD-BE90-7A1DB2E43A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2474261"/>
              </p:ext>
            </p:extLst>
          </p:nvPr>
        </p:nvGraphicFramePr>
        <p:xfrm>
          <a:off x="6619875" y="2335213"/>
          <a:ext cx="3390900" cy="250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3390409" imgH="2505333" progId="Prism8.Document">
                  <p:embed/>
                </p:oleObj>
              </mc:Choice>
              <mc:Fallback>
                <p:oleObj name="Prism 8" r:id="rId3" imgW="3390409" imgH="250533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19875" y="2335213"/>
                        <a:ext cx="3390900" cy="2505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xmlns="" id="{C0350ADF-928A-4D93-A4E3-8A14E96C92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5566488"/>
              </p:ext>
            </p:extLst>
          </p:nvPr>
        </p:nvGraphicFramePr>
        <p:xfrm>
          <a:off x="1746250" y="2263775"/>
          <a:ext cx="3390900" cy="250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5" imgW="3390409" imgH="2505333" progId="Prism8.Document">
                  <p:embed/>
                </p:oleObj>
              </mc:Choice>
              <mc:Fallback>
                <p:oleObj name="Prism 8" r:id="rId5" imgW="3390409" imgH="250533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46250" y="2263775"/>
                        <a:ext cx="3390900" cy="2505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CB2EBD48-27BB-4913-8340-4D2241CFE2D2}"/>
              </a:ext>
            </a:extLst>
          </p:cNvPr>
          <p:cNvSpPr txBox="1"/>
          <p:nvPr/>
        </p:nvSpPr>
        <p:spPr>
          <a:xfrm>
            <a:off x="1482571" y="1012054"/>
            <a:ext cx="2430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</a:t>
            </a:r>
            <a:r>
              <a:rPr lang="ja-JP" altLang="en-US" dirty="0"/>
              <a:t> </a:t>
            </a:r>
            <a:r>
              <a:rPr kumimoji="1" lang="en-US" altLang="ja-JP" dirty="0"/>
              <a:t>Fig.1a </a:t>
            </a:r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7653905A-C28A-409B-B8C3-47A98CA2E348}"/>
              </a:ext>
            </a:extLst>
          </p:cNvPr>
          <p:cNvSpPr txBox="1"/>
          <p:nvPr/>
        </p:nvSpPr>
        <p:spPr>
          <a:xfrm>
            <a:off x="6623143" y="1012054"/>
            <a:ext cx="2436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. 1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19343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xmlns="" id="{18C54C58-AA92-4085-96FC-596D99F02E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9805944"/>
              </p:ext>
            </p:extLst>
          </p:nvPr>
        </p:nvGraphicFramePr>
        <p:xfrm>
          <a:off x="1680839" y="1782763"/>
          <a:ext cx="3655507" cy="3607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8" r:id="rId3" imgW="3390409" imgH="3346203" progId="Prism8.Document">
                  <p:embed/>
                </p:oleObj>
              </mc:Choice>
              <mc:Fallback>
                <p:oleObj name="Prism 8" r:id="rId3" imgW="3390409" imgH="3346203" progId="Prism8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xmlns="" id="{0FDCCD4C-2088-4BC6-BFCB-725B928161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80839" y="1782763"/>
                        <a:ext cx="3655507" cy="3607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90399137-015C-40B1-BB9B-A114674B1B5A}"/>
              </a:ext>
            </a:extLst>
          </p:cNvPr>
          <p:cNvSpPr txBox="1"/>
          <p:nvPr/>
        </p:nvSpPr>
        <p:spPr>
          <a:xfrm>
            <a:off x="2022535" y="1727846"/>
            <a:ext cx="221942" cy="255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/>
              <a:t>A</a:t>
            </a:r>
            <a:endParaRPr kumimoji="1" lang="ja-JP" altLang="en-US" sz="10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8D1B7B93-A3F6-4CD9-A53E-9815ECAFCB5C}"/>
              </a:ext>
            </a:extLst>
          </p:cNvPr>
          <p:cNvSpPr txBox="1"/>
          <p:nvPr/>
        </p:nvSpPr>
        <p:spPr>
          <a:xfrm>
            <a:off x="2884764" y="2529292"/>
            <a:ext cx="2712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B</a:t>
            </a:r>
            <a:endParaRPr kumimoji="1" lang="ja-JP" altLang="en-US" sz="10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9225272F-4BF7-4617-8C03-87B54FC9FA33}"/>
              </a:ext>
            </a:extLst>
          </p:cNvPr>
          <p:cNvSpPr txBox="1"/>
          <p:nvPr/>
        </p:nvSpPr>
        <p:spPr>
          <a:xfrm>
            <a:off x="4078699" y="3937617"/>
            <a:ext cx="2728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C</a:t>
            </a:r>
            <a:endParaRPr kumimoji="1" lang="ja-JP" altLang="en-US" sz="10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7274407B-4CAE-4765-9DFE-7744DAD98732}"/>
              </a:ext>
            </a:extLst>
          </p:cNvPr>
          <p:cNvSpPr txBox="1"/>
          <p:nvPr/>
        </p:nvSpPr>
        <p:spPr>
          <a:xfrm>
            <a:off x="2862448" y="4038259"/>
            <a:ext cx="2808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D</a:t>
            </a:r>
            <a:endParaRPr kumimoji="1" lang="ja-JP" altLang="en-US" sz="10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09E1643B-4B41-489B-A3FE-B169EC96E6FF}"/>
              </a:ext>
            </a:extLst>
          </p:cNvPr>
          <p:cNvSpPr txBox="1"/>
          <p:nvPr/>
        </p:nvSpPr>
        <p:spPr>
          <a:xfrm>
            <a:off x="2514481" y="2855305"/>
            <a:ext cx="2574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E</a:t>
            </a:r>
            <a:endParaRPr kumimoji="1" lang="ja-JP" altLang="en-US" sz="10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B02CB5E2-5CEF-497C-86B2-E8476D371221}"/>
              </a:ext>
            </a:extLst>
          </p:cNvPr>
          <p:cNvSpPr txBox="1"/>
          <p:nvPr/>
        </p:nvSpPr>
        <p:spPr>
          <a:xfrm>
            <a:off x="2888771" y="4366032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F</a:t>
            </a:r>
            <a:endParaRPr kumimoji="1" lang="ja-JP" altLang="en-US" sz="10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B90F126E-1BF5-4450-AC8E-4838ED54DAC4}"/>
              </a:ext>
            </a:extLst>
          </p:cNvPr>
          <p:cNvSpPr txBox="1"/>
          <p:nvPr/>
        </p:nvSpPr>
        <p:spPr>
          <a:xfrm>
            <a:off x="2500706" y="4315712"/>
            <a:ext cx="271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G</a:t>
            </a:r>
            <a:endParaRPr kumimoji="1" lang="ja-JP" altLang="en-US" sz="1000" dirty="0"/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xmlns="" id="{5E81896B-0CF5-4CF5-AB7B-62D3F02A1CA2}"/>
              </a:ext>
            </a:extLst>
          </p:cNvPr>
          <p:cNvCxnSpPr>
            <a:cxnSpLocks/>
          </p:cNvCxnSpPr>
          <p:nvPr/>
        </p:nvCxnSpPr>
        <p:spPr>
          <a:xfrm flipH="1">
            <a:off x="4960691" y="2005346"/>
            <a:ext cx="8551" cy="8134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3" name="オブジェクト 12">
            <a:extLst>
              <a:ext uri="{FF2B5EF4-FFF2-40B4-BE49-F238E27FC236}">
                <a16:creationId xmlns:a16="http://schemas.microsoft.com/office/drawing/2014/main" xmlns="" id="{690F55A6-699E-4D29-BBA2-1C75B342EE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9380446"/>
              </p:ext>
            </p:extLst>
          </p:nvPr>
        </p:nvGraphicFramePr>
        <p:xfrm>
          <a:off x="5584790" y="1683737"/>
          <a:ext cx="5496852" cy="38056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8" r:id="rId5" imgW="3616101" imgH="2505333" progId="Prism8.Document">
                  <p:embed/>
                </p:oleObj>
              </mc:Choice>
              <mc:Fallback>
                <p:oleObj name="Prism 8" r:id="rId5" imgW="3616101" imgH="250533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584790" y="1683737"/>
                        <a:ext cx="5496852" cy="38056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xmlns="" id="{6BBFB6CA-C697-4BB8-96C8-83ED8E7889FE}"/>
              </a:ext>
            </a:extLst>
          </p:cNvPr>
          <p:cNvCxnSpPr>
            <a:cxnSpLocks/>
          </p:cNvCxnSpPr>
          <p:nvPr/>
        </p:nvCxnSpPr>
        <p:spPr>
          <a:xfrm>
            <a:off x="6731912" y="1888815"/>
            <a:ext cx="7474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6585BCD5-DC24-4FB8-B348-F4D74C8A6428}"/>
              </a:ext>
            </a:extLst>
          </p:cNvPr>
          <p:cNvSpPr txBox="1"/>
          <p:nvPr/>
        </p:nvSpPr>
        <p:spPr>
          <a:xfrm>
            <a:off x="1472184" y="734108"/>
            <a:ext cx="2430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</a:t>
            </a:r>
            <a:r>
              <a:rPr lang="en-US" altLang="ja-JP" dirty="0"/>
              <a:t>Fig. 2a</a:t>
            </a:r>
            <a:endParaRPr kumimoji="1" lang="en-US" altLang="ja-JP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4120823A-B433-4651-B858-02AC685C0B48}"/>
              </a:ext>
            </a:extLst>
          </p:cNvPr>
          <p:cNvSpPr txBox="1"/>
          <p:nvPr/>
        </p:nvSpPr>
        <p:spPr>
          <a:xfrm>
            <a:off x="5942597" y="734108"/>
            <a:ext cx="2436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. 2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92523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xmlns="" id="{B8750BA5-60FC-4160-A0DA-BA196F867F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7675702"/>
              </p:ext>
            </p:extLst>
          </p:nvPr>
        </p:nvGraphicFramePr>
        <p:xfrm>
          <a:off x="590827" y="1434669"/>
          <a:ext cx="5283200" cy="461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8" r:id="rId3" imgW="3693851" imgH="3224536" progId="Prism8.Document">
                  <p:embed/>
                </p:oleObj>
              </mc:Choice>
              <mc:Fallback>
                <p:oleObj name="Prism 8" r:id="rId3" imgW="3693851" imgH="32245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0827" y="1434669"/>
                        <a:ext cx="5283200" cy="461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xmlns="" id="{25033D67-AED1-4CD8-833B-2E26AD3075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3404149"/>
              </p:ext>
            </p:extLst>
          </p:nvPr>
        </p:nvGraphicFramePr>
        <p:xfrm>
          <a:off x="6020713" y="1434669"/>
          <a:ext cx="5580460" cy="461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8" r:id="rId5" imgW="3902624" imgH="3224536" progId="Prism8.Document">
                  <p:embed/>
                </p:oleObj>
              </mc:Choice>
              <mc:Fallback>
                <p:oleObj name="Prism 8" r:id="rId5" imgW="3902624" imgH="3224536" progId="Prism8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xmlns="" id="{2AFCE028-C0A9-41BE-AB81-69D61F238E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20713" y="1434669"/>
                        <a:ext cx="5580460" cy="461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D2024419-E8C7-3D3C-EE57-398B1EDA5BC5}"/>
              </a:ext>
            </a:extLst>
          </p:cNvPr>
          <p:cNvSpPr txBox="1"/>
          <p:nvPr/>
        </p:nvSpPr>
        <p:spPr>
          <a:xfrm>
            <a:off x="1298856" y="372862"/>
            <a:ext cx="2503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l Fig. 3</a:t>
            </a:r>
            <a:r>
              <a:rPr lang="en-US" altLang="ja-JP" dirty="0"/>
              <a:t>a</a:t>
            </a:r>
            <a:endParaRPr kumimoji="1" lang="en-US" altLang="ja-JP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2E49F0A5-2BEB-2607-DB68-ECEDE0D2A946}"/>
              </a:ext>
            </a:extLst>
          </p:cNvPr>
          <p:cNvSpPr txBox="1"/>
          <p:nvPr/>
        </p:nvSpPr>
        <p:spPr>
          <a:xfrm>
            <a:off x="7401143" y="273459"/>
            <a:ext cx="2503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l Fig. 3b</a:t>
            </a:r>
          </a:p>
        </p:txBody>
      </p:sp>
    </p:spTree>
    <p:extLst>
      <p:ext uri="{BB962C8B-B14F-4D97-AF65-F5344CB8AC3E}">
        <p14:creationId xmlns:p14="http://schemas.microsoft.com/office/powerpoint/2010/main" val="2980947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xmlns="" id="{07E700DB-98A5-409A-B12F-0EA89197AE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0453872"/>
              </p:ext>
            </p:extLst>
          </p:nvPr>
        </p:nvGraphicFramePr>
        <p:xfrm>
          <a:off x="1005618" y="1658505"/>
          <a:ext cx="3968315" cy="30906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8" r:id="rId3" imgW="3373852" imgH="2627000" progId="Prism8.Document">
                  <p:embed/>
                </p:oleObj>
              </mc:Choice>
              <mc:Fallback>
                <p:oleObj name="Prism 8" r:id="rId3" imgW="3373852" imgH="2627000" progId="Prism8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xmlns="" id="{3CF69D3C-76BC-4BB5-A497-FFE3E0FC80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05618" y="1658505"/>
                        <a:ext cx="3968315" cy="30906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xmlns="" id="{6CF3074D-39AE-47E2-8CC5-1A5F4CD6AB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4112345"/>
              </p:ext>
            </p:extLst>
          </p:nvPr>
        </p:nvGraphicFramePr>
        <p:xfrm>
          <a:off x="6504375" y="1658505"/>
          <a:ext cx="3184450" cy="30906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8" r:id="rId5" imgW="3448362" imgH="3346203" progId="Prism8.Document">
                  <p:embed/>
                </p:oleObj>
              </mc:Choice>
              <mc:Fallback>
                <p:oleObj name="Prism 8" r:id="rId5" imgW="3448362" imgH="3346203" progId="Prism8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xmlns="" id="{C431B493-2894-4B04-A169-4E4442A00E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504375" y="1658505"/>
                        <a:ext cx="3184450" cy="30906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C5C04696-7730-45BA-8007-8073C6B4746F}"/>
              </a:ext>
            </a:extLst>
          </p:cNvPr>
          <p:cNvSpPr txBox="1"/>
          <p:nvPr/>
        </p:nvSpPr>
        <p:spPr>
          <a:xfrm>
            <a:off x="1305016" y="372862"/>
            <a:ext cx="2503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l Fig. 4</a:t>
            </a:r>
            <a:r>
              <a:rPr lang="en-US" altLang="ja-JP" dirty="0"/>
              <a:t>a</a:t>
            </a:r>
            <a:endParaRPr kumimoji="1" lang="en-US" altLang="ja-JP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ADFE4215-0BA0-471B-8FF6-A0A96450F10C}"/>
              </a:ext>
            </a:extLst>
          </p:cNvPr>
          <p:cNvSpPr txBox="1"/>
          <p:nvPr/>
        </p:nvSpPr>
        <p:spPr>
          <a:xfrm>
            <a:off x="6340134" y="372862"/>
            <a:ext cx="2503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l Fig. 4b</a:t>
            </a:r>
          </a:p>
        </p:txBody>
      </p:sp>
    </p:spTree>
    <p:extLst>
      <p:ext uri="{BB962C8B-B14F-4D97-AF65-F5344CB8AC3E}">
        <p14:creationId xmlns:p14="http://schemas.microsoft.com/office/powerpoint/2010/main" val="38283221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xmlns="" id="{8964E108-CCFB-4F4D-A37D-1B45FE6B3D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073363"/>
              </p:ext>
            </p:extLst>
          </p:nvPr>
        </p:nvGraphicFramePr>
        <p:xfrm>
          <a:off x="374650" y="2209800"/>
          <a:ext cx="6027738" cy="3224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8" r:id="rId3" imgW="6028154" imgH="3224536" progId="Prism8.Document">
                  <p:embed/>
                </p:oleObj>
              </mc:Choice>
              <mc:Fallback>
                <p:oleObj name="Prism 8" r:id="rId3" imgW="6028154" imgH="32245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4650" y="2209800"/>
                        <a:ext cx="6027738" cy="3224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D3677D23-57AD-4E0A-A8E2-2CD946866270}"/>
              </a:ext>
            </a:extLst>
          </p:cNvPr>
          <p:cNvSpPr txBox="1"/>
          <p:nvPr/>
        </p:nvSpPr>
        <p:spPr>
          <a:xfrm>
            <a:off x="731609" y="553594"/>
            <a:ext cx="2430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</a:t>
            </a:r>
            <a:r>
              <a:rPr lang="en-US" altLang="ja-JP" dirty="0"/>
              <a:t>Fig. 5a</a:t>
            </a:r>
            <a:endParaRPr kumimoji="1" lang="ja-JP" altLang="en-US" dirty="0"/>
          </a:p>
        </p:txBody>
      </p:sp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xmlns="" id="{3B92B1F5-1BA6-4B48-AE78-27FC3C3965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0666503"/>
              </p:ext>
            </p:extLst>
          </p:nvPr>
        </p:nvGraphicFramePr>
        <p:xfrm>
          <a:off x="7184517" y="2209799"/>
          <a:ext cx="4240212" cy="3224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Prism 8" r:id="rId5" imgW="4240621" imgH="3224536" progId="Prism8.Document">
                  <p:embed/>
                </p:oleObj>
              </mc:Choice>
              <mc:Fallback>
                <p:oleObj name="Prism 8" r:id="rId5" imgW="4240621" imgH="3224536" progId="Prism8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xmlns="" id="{1A7EFBDC-6E69-42A6-9F32-EE3495E285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184517" y="2209799"/>
                        <a:ext cx="4240212" cy="3224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F54A1683-4F57-484D-BD77-F78FD5476018}"/>
              </a:ext>
            </a:extLst>
          </p:cNvPr>
          <p:cNvSpPr txBox="1"/>
          <p:nvPr/>
        </p:nvSpPr>
        <p:spPr>
          <a:xfrm>
            <a:off x="6560077" y="553594"/>
            <a:ext cx="2436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</a:t>
            </a:r>
            <a:r>
              <a:rPr lang="en-US" altLang="ja-JP" dirty="0"/>
              <a:t>Fig. 5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167334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xmlns="" id="{A3A32754-B423-4694-BC06-9C33979E05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3955633"/>
              </p:ext>
            </p:extLst>
          </p:nvPr>
        </p:nvGraphicFramePr>
        <p:xfrm>
          <a:off x="985912" y="1969811"/>
          <a:ext cx="4917206" cy="30016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6" name="Prism 8" r:id="rId3" imgW="4103479" imgH="2505333" progId="Prism8.Document">
                  <p:embed/>
                </p:oleObj>
              </mc:Choice>
              <mc:Fallback>
                <p:oleObj name="Prism 8" r:id="rId3" imgW="4103479" imgH="250533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85912" y="1969811"/>
                        <a:ext cx="4917206" cy="30016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xmlns="" id="{63795764-9220-46E7-B7C2-850B0543EB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2374956"/>
              </p:ext>
            </p:extLst>
          </p:nvPr>
        </p:nvGraphicFramePr>
        <p:xfrm>
          <a:off x="6102453" y="1969811"/>
          <a:ext cx="5851788" cy="30016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7" name="Prism 8" r:id="rId5" imgW="4351847" imgH="2232482" progId="Prism8.Document">
                  <p:embed/>
                </p:oleObj>
              </mc:Choice>
              <mc:Fallback>
                <p:oleObj name="Prism 8" r:id="rId5" imgW="4351847" imgH="223248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02453" y="1969811"/>
                        <a:ext cx="5851788" cy="30016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4FBA10EA-C8B8-41C3-8CDD-9B372A96AAA0}"/>
              </a:ext>
            </a:extLst>
          </p:cNvPr>
          <p:cNvSpPr txBox="1"/>
          <p:nvPr/>
        </p:nvSpPr>
        <p:spPr>
          <a:xfrm>
            <a:off x="873051" y="872231"/>
            <a:ext cx="2430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</a:t>
            </a:r>
            <a:r>
              <a:rPr lang="en-US" altLang="ja-JP" dirty="0"/>
              <a:t>Fig. 6a</a:t>
            </a:r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A24AFB95-5FE6-4A13-BC76-7C1B46CECFED}"/>
              </a:ext>
            </a:extLst>
          </p:cNvPr>
          <p:cNvSpPr txBox="1"/>
          <p:nvPr/>
        </p:nvSpPr>
        <p:spPr>
          <a:xfrm>
            <a:off x="5997326" y="872231"/>
            <a:ext cx="2436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</a:t>
            </a:r>
            <a:r>
              <a:rPr lang="en-US" altLang="ja-JP" dirty="0"/>
              <a:t>Fig. 6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668390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xmlns="" id="{F439272B-4780-E5EA-BBC7-7F287CE2FF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2761125"/>
              </p:ext>
            </p:extLst>
          </p:nvPr>
        </p:nvGraphicFramePr>
        <p:xfrm>
          <a:off x="3568700" y="1635125"/>
          <a:ext cx="4537075" cy="3844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0" name="Prism 8" r:id="rId3" imgW="3757563" imgH="3184940" progId="Prism8.Document">
                  <p:embed/>
                </p:oleObj>
              </mc:Choice>
              <mc:Fallback>
                <p:oleObj name="Prism 8" r:id="rId3" imgW="3757563" imgH="318494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68700" y="1635125"/>
                        <a:ext cx="4537075" cy="3844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22DF47C0-B6A6-6119-96A2-2DF393290085}"/>
              </a:ext>
            </a:extLst>
          </p:cNvPr>
          <p:cNvSpPr txBox="1"/>
          <p:nvPr/>
        </p:nvSpPr>
        <p:spPr>
          <a:xfrm>
            <a:off x="2148397" y="1002591"/>
            <a:ext cx="2236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.7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43962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xmlns="" id="{ECDEEAB1-A1F0-49C1-8949-569D7D0F4A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4180524"/>
              </p:ext>
            </p:extLst>
          </p:nvPr>
        </p:nvGraphicFramePr>
        <p:xfrm>
          <a:off x="5692484" y="1196975"/>
          <a:ext cx="5235575" cy="4933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4" name="Prism 8" r:id="rId3" imgW="3421006" imgH="3224536" progId="Prism8.Document">
                  <p:embed/>
                </p:oleObj>
              </mc:Choice>
              <mc:Fallback>
                <p:oleObj name="Prism 8" r:id="rId3" imgW="3421006" imgH="3224536" progId="Prism8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xmlns="" id="{935B60E7-EBE3-4E35-BC62-6543AC5375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692484" y="1196975"/>
                        <a:ext cx="5235575" cy="4933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533CA427-F7F0-40B9-B610-4336F9581E44}"/>
              </a:ext>
            </a:extLst>
          </p:cNvPr>
          <p:cNvSpPr txBox="1"/>
          <p:nvPr/>
        </p:nvSpPr>
        <p:spPr>
          <a:xfrm>
            <a:off x="6013695" y="462548"/>
            <a:ext cx="2436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</a:t>
            </a:r>
            <a:r>
              <a:rPr lang="en-US" altLang="ja-JP" dirty="0"/>
              <a:t>Fig. 8b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9D309D90-3186-4078-8BF8-EC84E7DAFCC5}"/>
              </a:ext>
            </a:extLst>
          </p:cNvPr>
          <p:cNvSpPr txBox="1"/>
          <p:nvPr/>
        </p:nvSpPr>
        <p:spPr>
          <a:xfrm>
            <a:off x="668904" y="591375"/>
            <a:ext cx="2430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</a:t>
            </a:r>
            <a:r>
              <a:rPr lang="en-US" altLang="ja-JP" dirty="0"/>
              <a:t>Fig. 8a</a:t>
            </a:r>
          </a:p>
        </p:txBody>
      </p:sp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xmlns="" id="{81428F95-EFFB-40EA-9A1E-7311915EB6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6847297"/>
              </p:ext>
            </p:extLst>
          </p:nvPr>
        </p:nvGraphicFramePr>
        <p:xfrm>
          <a:off x="778120" y="1196609"/>
          <a:ext cx="5235575" cy="4934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5" name="Prism 8" r:id="rId5" imgW="3421006" imgH="3224536" progId="Prism8.Document">
                  <p:embed/>
                </p:oleObj>
              </mc:Choice>
              <mc:Fallback>
                <p:oleObj name="Prism 8" r:id="rId5" imgW="3421006" imgH="3224536" progId="Prism8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xmlns="" id="{529FA9F5-6FBD-4A63-AD3D-C58D6DD7AA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78120" y="1196609"/>
                        <a:ext cx="5235575" cy="49343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034334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xmlns="" id="{05490E14-135B-9F85-9262-03A3A5FD89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0085582"/>
              </p:ext>
            </p:extLst>
          </p:nvPr>
        </p:nvGraphicFramePr>
        <p:xfrm>
          <a:off x="1268243" y="1847423"/>
          <a:ext cx="4827757" cy="33407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8" name="Prism 8" r:id="rId3" imgW="3344695" imgH="2314553" progId="Prism8.Document">
                  <p:embed/>
                </p:oleObj>
              </mc:Choice>
              <mc:Fallback>
                <p:oleObj name="Prism 8" r:id="rId3" imgW="3344695" imgH="2314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68243" y="1847423"/>
                        <a:ext cx="4827757" cy="33407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xmlns="" id="{D245CB85-BC25-00C2-6F85-BEB78ECD3F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3180869"/>
              </p:ext>
            </p:extLst>
          </p:nvPr>
        </p:nvGraphicFramePr>
        <p:xfrm>
          <a:off x="6859588" y="1847850"/>
          <a:ext cx="4532312" cy="334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9" name="Prism 8" r:id="rId5" imgW="3934300" imgH="2899851" progId="Prism8.Document">
                  <p:embed/>
                </p:oleObj>
              </mc:Choice>
              <mc:Fallback>
                <p:oleObj name="Prism 8" r:id="rId5" imgW="3934300" imgH="289985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859588" y="1847850"/>
                        <a:ext cx="4532312" cy="334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D85710DA-2215-3E1C-134C-21A708A26818}"/>
              </a:ext>
            </a:extLst>
          </p:cNvPr>
          <p:cNvSpPr txBox="1"/>
          <p:nvPr/>
        </p:nvSpPr>
        <p:spPr>
          <a:xfrm>
            <a:off x="668904" y="591375"/>
            <a:ext cx="2430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</a:t>
            </a:r>
            <a:r>
              <a:rPr lang="en-US" altLang="ja-JP" dirty="0"/>
              <a:t>Fig. 9a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70BE4DE5-62DD-9197-9373-476D82F02106}"/>
              </a:ext>
            </a:extLst>
          </p:cNvPr>
          <p:cNvSpPr txBox="1"/>
          <p:nvPr/>
        </p:nvSpPr>
        <p:spPr>
          <a:xfrm>
            <a:off x="6013695" y="462548"/>
            <a:ext cx="2436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</a:t>
            </a:r>
            <a:r>
              <a:rPr lang="en-US" altLang="ja-JP" dirty="0"/>
              <a:t>Fig. 9b</a:t>
            </a:r>
          </a:p>
        </p:txBody>
      </p:sp>
    </p:spTree>
    <p:extLst>
      <p:ext uri="{BB962C8B-B14F-4D97-AF65-F5344CB8AC3E}">
        <p14:creationId xmlns:p14="http://schemas.microsoft.com/office/powerpoint/2010/main" val="895765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67</TotalTime>
  <Words>71</Words>
  <Application>Microsoft Office PowerPoint</Application>
  <PresentationFormat>Custom</PresentationFormat>
  <Paragraphs>24</Paragraphs>
  <Slides>9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1" baseType="lpstr">
      <vt:lpstr>Office テーマ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荻 真</dc:creator>
  <cp:lastModifiedBy>Marven Dalisay</cp:lastModifiedBy>
  <cp:revision>278</cp:revision>
  <cp:lastPrinted>2022-03-17T11:09:43Z</cp:lastPrinted>
  <dcterms:created xsi:type="dcterms:W3CDTF">2021-07-31T23:08:54Z</dcterms:created>
  <dcterms:modified xsi:type="dcterms:W3CDTF">2022-10-18T04:51:03Z</dcterms:modified>
</cp:coreProperties>
</file>